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71993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BB2735-3CBB-48A9-9781-F15E06BEFDE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822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4161600"/>
            <a:ext cx="822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E1C8E4-F779-4A4A-8A26-9E76EC4CEB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416160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416160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0B0D57-DE62-47A3-AE31-2356D623B90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7904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7904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416160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416160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416160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42C03F-BA4A-4293-B922-734CFE4FDA0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79040"/>
            <a:ext cx="8229600" cy="4753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3B5C7B-3416-4991-B588-BD4BE1B2CC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82296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C09E0A-D2BA-4259-8E04-9C765188290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40158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79040"/>
            <a:ext cx="40158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B29466-D1CF-48FE-B1CA-BF21993536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DF7017-6389-4424-8E66-25C966E617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88720"/>
            <a:ext cx="8229600" cy="5563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812200-B0EE-4B94-8E93-DFB90B0D9F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79040"/>
            <a:ext cx="40158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416160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FF4FF1-BA66-49CF-AEC5-D511682393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40158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416160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36DBFA-DCF6-49F1-AC57-165DD21E1D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4161600"/>
            <a:ext cx="822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9D211D-ED04-4A98-8A93-0A3CF49521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79040"/>
            <a:ext cx="82296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673680"/>
            <a:ext cx="2133720" cy="38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673680"/>
            <a:ext cx="2895840" cy="38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673680"/>
            <a:ext cx="2133720" cy="38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3B7E7C0-24D0-4CFE-A11E-6A41BEBD1213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468360" y="6527880"/>
            <a:ext cx="8136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le S3: Arabidopsis microarray expression data of development stages showing the expression profile of 12 candidate reference genes considered in this study (available at jsp.weigelworld.org)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Chart 5" descr=""/>
          <p:cNvPicPr/>
          <p:nvPr/>
        </p:nvPicPr>
        <p:blipFill>
          <a:blip r:embed="rId1"/>
          <a:stretch/>
        </p:blipFill>
        <p:spPr>
          <a:xfrm>
            <a:off x="244440" y="933480"/>
            <a:ext cx="8655120" cy="5321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01T06:51:40Z</dcterms:created>
  <dc:creator>NCB203</dc:creator>
  <dc:description/>
  <dc:language>en-US</dc:language>
  <cp:lastModifiedBy>NIPGR</cp:lastModifiedBy>
  <dcterms:modified xsi:type="dcterms:W3CDTF">2012-04-18T11:53:15Z</dcterms:modified>
  <cp:revision>94</cp:revision>
  <dc:subject/>
  <dc:title>Slide 1</dc:title>
</cp:coreProperties>
</file>